
<file path=[Content_Types].xml><?xml version="1.0" encoding="utf-8"?>
<Types xmlns="http://schemas.openxmlformats.org/package/2006/content-types">
  <Default Extension="fntdata" ContentType="application/x-fontdata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embedTrueTypeFonts="1" saveSubsetFonts="1">
  <p:sldMasterIdLst>
    <p:sldMasterId id="2147483648" r:id="rId4"/>
  </p:sldMasterIdLst>
  <p:notesMasterIdLst>
    <p:notesMasterId r:id="rId8"/>
  </p:notesMasterIdLst>
  <p:handoutMasterIdLst>
    <p:handoutMasterId r:id="rId9"/>
  </p:handoutMasterIdLst>
  <p:sldIdLst>
    <p:sldId id="1232" r:id="rId5"/>
    <p:sldId id="1233" r:id="rId6"/>
    <p:sldId id="1203" r:id="rId7"/>
  </p:sldIdLst>
  <p:sldSz cx="10799763" cy="8999538"/>
  <p:notesSz cx="9926638" cy="6797675"/>
  <p:embeddedFontLst>
    <p:embeddedFont>
      <p:font typeface="나눔바른고딕" panose="020B0600000101010101" charset="-127"/>
      <p:regular r:id="rId10"/>
      <p:bold r:id="rId11"/>
    </p:embeddedFont>
    <p:embeddedFont>
      <p:font typeface="맑은 고딕" panose="020B0503020000020004" pitchFamily="50" charset="-127"/>
      <p:regular r:id="rId12"/>
      <p:bold r:id="rId13"/>
    </p:embeddedFont>
  </p:embeddedFontLst>
  <p:defaultTextStyle>
    <a:defPPr>
      <a:defRPr lang="ko-KR"/>
    </a:defPPr>
    <a:lvl1pPr marL="0" algn="l" defTabSz="1131225" rtl="0" eaLnBrk="1" latinLnBrk="1" hangingPunct="1">
      <a:defRPr sz="2227" kern="1200">
        <a:solidFill>
          <a:schemeClr val="tx1"/>
        </a:solidFill>
        <a:latin typeface="+mn-lt"/>
        <a:ea typeface="+mn-ea"/>
        <a:cs typeface="+mn-cs"/>
      </a:defRPr>
    </a:lvl1pPr>
    <a:lvl2pPr marL="565613" algn="l" defTabSz="1131225" rtl="0" eaLnBrk="1" latinLnBrk="1" hangingPunct="1">
      <a:defRPr sz="2227" kern="1200">
        <a:solidFill>
          <a:schemeClr val="tx1"/>
        </a:solidFill>
        <a:latin typeface="+mn-lt"/>
        <a:ea typeface="+mn-ea"/>
        <a:cs typeface="+mn-cs"/>
      </a:defRPr>
    </a:lvl2pPr>
    <a:lvl3pPr marL="1131225" algn="l" defTabSz="1131225" rtl="0" eaLnBrk="1" latinLnBrk="1" hangingPunct="1">
      <a:defRPr sz="2227" kern="1200">
        <a:solidFill>
          <a:schemeClr val="tx1"/>
        </a:solidFill>
        <a:latin typeface="+mn-lt"/>
        <a:ea typeface="+mn-ea"/>
        <a:cs typeface="+mn-cs"/>
      </a:defRPr>
    </a:lvl3pPr>
    <a:lvl4pPr marL="1696839" algn="l" defTabSz="1131225" rtl="0" eaLnBrk="1" latinLnBrk="1" hangingPunct="1">
      <a:defRPr sz="2227" kern="1200">
        <a:solidFill>
          <a:schemeClr val="tx1"/>
        </a:solidFill>
        <a:latin typeface="+mn-lt"/>
        <a:ea typeface="+mn-ea"/>
        <a:cs typeface="+mn-cs"/>
      </a:defRPr>
    </a:lvl4pPr>
    <a:lvl5pPr marL="2262453" algn="l" defTabSz="1131225" rtl="0" eaLnBrk="1" latinLnBrk="1" hangingPunct="1">
      <a:defRPr sz="2227" kern="1200">
        <a:solidFill>
          <a:schemeClr val="tx1"/>
        </a:solidFill>
        <a:latin typeface="+mn-lt"/>
        <a:ea typeface="+mn-ea"/>
        <a:cs typeface="+mn-cs"/>
      </a:defRPr>
    </a:lvl5pPr>
    <a:lvl6pPr marL="2828068" algn="l" defTabSz="1131225" rtl="0" eaLnBrk="1" latinLnBrk="1" hangingPunct="1">
      <a:defRPr sz="2227" kern="1200">
        <a:solidFill>
          <a:schemeClr val="tx1"/>
        </a:solidFill>
        <a:latin typeface="+mn-lt"/>
        <a:ea typeface="+mn-ea"/>
        <a:cs typeface="+mn-cs"/>
      </a:defRPr>
    </a:lvl6pPr>
    <a:lvl7pPr marL="3393679" algn="l" defTabSz="1131225" rtl="0" eaLnBrk="1" latinLnBrk="1" hangingPunct="1">
      <a:defRPr sz="2227" kern="1200">
        <a:solidFill>
          <a:schemeClr val="tx1"/>
        </a:solidFill>
        <a:latin typeface="+mn-lt"/>
        <a:ea typeface="+mn-ea"/>
        <a:cs typeface="+mn-cs"/>
      </a:defRPr>
    </a:lvl7pPr>
    <a:lvl8pPr marL="3959293" algn="l" defTabSz="1131225" rtl="0" eaLnBrk="1" latinLnBrk="1" hangingPunct="1">
      <a:defRPr sz="2227" kern="1200">
        <a:solidFill>
          <a:schemeClr val="tx1"/>
        </a:solidFill>
        <a:latin typeface="+mn-lt"/>
        <a:ea typeface="+mn-ea"/>
        <a:cs typeface="+mn-cs"/>
      </a:defRPr>
    </a:lvl8pPr>
    <a:lvl9pPr marL="4524906" algn="l" defTabSz="1131225" rtl="0" eaLnBrk="1" latinLnBrk="1" hangingPunct="1">
      <a:defRPr sz="222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06" userDrawn="1">
          <p15:clr>
            <a:srgbClr val="A4A3A4"/>
          </p15:clr>
        </p15:guide>
        <p15:guide id="2" orient="horz" pos="4680" userDrawn="1">
          <p15:clr>
            <a:srgbClr val="A4A3A4"/>
          </p15:clr>
        </p15:guide>
        <p15:guide id="3" orient="horz" pos="4858" userDrawn="1">
          <p15:clr>
            <a:srgbClr val="A4A3A4"/>
          </p15:clr>
        </p15:guide>
        <p15:guide id="4" pos="670" userDrawn="1">
          <p15:clr>
            <a:srgbClr val="A4A3A4"/>
          </p15:clr>
        </p15:guide>
        <p15:guide id="5" pos="3025" userDrawn="1">
          <p15:clr>
            <a:srgbClr val="A4A3A4"/>
          </p15:clr>
        </p15:guide>
        <p15:guide id="6" pos="1366" userDrawn="1">
          <p15:clr>
            <a:srgbClr val="A4A3A4"/>
          </p15:clr>
        </p15:guide>
        <p15:guide id="7" pos="3402" userDrawn="1">
          <p15:clr>
            <a:srgbClr val="A4A3A4"/>
          </p15:clr>
        </p15:guide>
        <p15:guide id="8" pos="597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CCCC00"/>
    <a:srgbClr val="FF9900"/>
    <a:srgbClr val="FFFF00"/>
    <a:srgbClr val="00FF00"/>
    <a:srgbClr val="00FFFF"/>
    <a:srgbClr val="FFCC00"/>
    <a:srgbClr val="FF33CC"/>
    <a:srgbClr val="CC9900"/>
    <a:srgbClr val="82C37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64" autoAdjust="0"/>
    <p:restoredTop sz="96429" autoAdjust="0"/>
  </p:normalViewPr>
  <p:slideViewPr>
    <p:cSldViewPr showGuides="1">
      <p:cViewPr varScale="1">
        <p:scale>
          <a:sx n="69" d="100"/>
          <a:sy n="69" d="100"/>
        </p:scale>
        <p:origin x="1578" y="60"/>
      </p:cViewPr>
      <p:guideLst>
        <p:guide orient="horz" pos="1406"/>
        <p:guide orient="horz" pos="4680"/>
        <p:guide orient="horz" pos="4858"/>
        <p:guide pos="670"/>
        <p:guide pos="3025"/>
        <p:guide pos="1366"/>
        <p:guide pos="3402"/>
        <p:guide pos="5973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font" Target="fonts/font4.fntdata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font" Target="fonts/font3.fntdata"/><Relationship Id="rId17" Type="http://schemas.openxmlformats.org/officeDocument/2006/relationships/tableStyles" Target="tableStyles.xml"/><Relationship Id="rId2" Type="http://schemas.openxmlformats.org/officeDocument/2006/relationships/customXml" Target="../customXml/item2.xml"/><Relationship Id="rId16" Type="http://schemas.openxmlformats.org/officeDocument/2006/relationships/theme" Target="theme/theme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font" Target="fonts/font2.fntdata"/><Relationship Id="rId5" Type="http://schemas.openxmlformats.org/officeDocument/2006/relationships/slide" Target="slides/slide1.xml"/><Relationship Id="rId15" Type="http://schemas.openxmlformats.org/officeDocument/2006/relationships/viewProps" Target="viewProps.xml"/><Relationship Id="rId10" Type="http://schemas.openxmlformats.org/officeDocument/2006/relationships/font" Target="fonts/font1.fntdata"/><Relationship Id="rId4" Type="http://schemas.openxmlformats.org/officeDocument/2006/relationships/slideMaster" Target="slideMasters/slideMaster1.xml"/><Relationship Id="rId9" Type="http://schemas.openxmlformats.org/officeDocument/2006/relationships/handoutMaster" Target="handoutMasters/handoutMaster1.xml"/><Relationship Id="rId1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8" y="1"/>
            <a:ext cx="4301543" cy="33988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5622806" y="1"/>
            <a:ext cx="4301543" cy="33988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1E32082-8547-4621-8CD8-765031764EC1}" type="datetimeFigureOut">
              <a:rPr lang="ko-KR" altLang="en-US" smtClean="0"/>
              <a:pPr/>
              <a:t>2019-08-23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8" y="6456611"/>
            <a:ext cx="4301543" cy="3398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5622806" y="6456611"/>
            <a:ext cx="4301543" cy="3398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9A470A-E601-4457-BCCE-032F2EE537D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83510920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8" y="1"/>
            <a:ext cx="4301543" cy="33988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5622806" y="1"/>
            <a:ext cx="4301543" cy="33988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3CD4D8-47CF-4D17-AB35-487CDF2348FF}" type="datetimeFigureOut">
              <a:rPr lang="ko-KR" altLang="en-US" smtClean="0"/>
              <a:pPr/>
              <a:t>2019-08-23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3433763" y="508000"/>
            <a:ext cx="3059112" cy="25511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992665" y="3228897"/>
            <a:ext cx="7941310" cy="305895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8" y="6456611"/>
            <a:ext cx="4301543" cy="3398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5622806" y="6456611"/>
            <a:ext cx="4301543" cy="3398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C92AA3-10D0-4EBB-A4CD-4BFE87A797E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167882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1131225" rtl="0" eaLnBrk="1" latinLnBrk="1" hangingPunct="1">
      <a:defRPr sz="1485" kern="1200">
        <a:solidFill>
          <a:schemeClr val="tx1"/>
        </a:solidFill>
        <a:latin typeface="+mn-lt"/>
        <a:ea typeface="+mn-ea"/>
        <a:cs typeface="+mn-cs"/>
      </a:defRPr>
    </a:lvl1pPr>
    <a:lvl2pPr marL="565613" algn="l" defTabSz="1131225" rtl="0" eaLnBrk="1" latinLnBrk="1" hangingPunct="1">
      <a:defRPr sz="1485" kern="1200">
        <a:solidFill>
          <a:schemeClr val="tx1"/>
        </a:solidFill>
        <a:latin typeface="+mn-lt"/>
        <a:ea typeface="+mn-ea"/>
        <a:cs typeface="+mn-cs"/>
      </a:defRPr>
    </a:lvl2pPr>
    <a:lvl3pPr marL="1131225" algn="l" defTabSz="1131225" rtl="0" eaLnBrk="1" latinLnBrk="1" hangingPunct="1">
      <a:defRPr sz="1485" kern="1200">
        <a:solidFill>
          <a:schemeClr val="tx1"/>
        </a:solidFill>
        <a:latin typeface="+mn-lt"/>
        <a:ea typeface="+mn-ea"/>
        <a:cs typeface="+mn-cs"/>
      </a:defRPr>
    </a:lvl3pPr>
    <a:lvl4pPr marL="1696839" algn="l" defTabSz="1131225" rtl="0" eaLnBrk="1" latinLnBrk="1" hangingPunct="1">
      <a:defRPr sz="1485" kern="1200">
        <a:solidFill>
          <a:schemeClr val="tx1"/>
        </a:solidFill>
        <a:latin typeface="+mn-lt"/>
        <a:ea typeface="+mn-ea"/>
        <a:cs typeface="+mn-cs"/>
      </a:defRPr>
    </a:lvl4pPr>
    <a:lvl5pPr marL="2262453" algn="l" defTabSz="1131225" rtl="0" eaLnBrk="1" latinLnBrk="1" hangingPunct="1">
      <a:defRPr sz="1485" kern="1200">
        <a:solidFill>
          <a:schemeClr val="tx1"/>
        </a:solidFill>
        <a:latin typeface="+mn-lt"/>
        <a:ea typeface="+mn-ea"/>
        <a:cs typeface="+mn-cs"/>
      </a:defRPr>
    </a:lvl5pPr>
    <a:lvl6pPr marL="2828068" algn="l" defTabSz="1131225" rtl="0" eaLnBrk="1" latinLnBrk="1" hangingPunct="1">
      <a:defRPr sz="1485" kern="1200">
        <a:solidFill>
          <a:schemeClr val="tx1"/>
        </a:solidFill>
        <a:latin typeface="+mn-lt"/>
        <a:ea typeface="+mn-ea"/>
        <a:cs typeface="+mn-cs"/>
      </a:defRPr>
    </a:lvl6pPr>
    <a:lvl7pPr marL="3393679" algn="l" defTabSz="1131225" rtl="0" eaLnBrk="1" latinLnBrk="1" hangingPunct="1">
      <a:defRPr sz="1485" kern="1200">
        <a:solidFill>
          <a:schemeClr val="tx1"/>
        </a:solidFill>
        <a:latin typeface="+mn-lt"/>
        <a:ea typeface="+mn-ea"/>
        <a:cs typeface="+mn-cs"/>
      </a:defRPr>
    </a:lvl7pPr>
    <a:lvl8pPr marL="3959293" algn="l" defTabSz="1131225" rtl="0" eaLnBrk="1" latinLnBrk="1" hangingPunct="1">
      <a:defRPr sz="1485" kern="1200">
        <a:solidFill>
          <a:schemeClr val="tx1"/>
        </a:solidFill>
        <a:latin typeface="+mn-lt"/>
        <a:ea typeface="+mn-ea"/>
        <a:cs typeface="+mn-cs"/>
      </a:defRPr>
    </a:lvl8pPr>
    <a:lvl9pPr marL="4524906" algn="l" defTabSz="1131225" rtl="0" eaLnBrk="1" latinLnBrk="1" hangingPunct="1">
      <a:defRPr sz="148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1165225" y="742950"/>
            <a:ext cx="4467225" cy="3724275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9C92AA3-10D0-4EBB-A4CD-4BFE87A797EE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1792616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1165225" y="742950"/>
            <a:ext cx="4467225" cy="3724275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9C92AA3-10D0-4EBB-A4CD-4BFE87A797EE}" type="slidenum">
              <a:rPr lang="ko-KR" altLang="en-US" smtClean="0"/>
              <a:pPr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936324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1165225" y="742950"/>
            <a:ext cx="4467225" cy="3724275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9C92AA3-10D0-4EBB-A4CD-4BFE87A797EE}" type="slidenum">
              <a:rPr lang="ko-KR" altLang="en-US" smtClean="0"/>
              <a:pPr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46665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809983" y="2795695"/>
            <a:ext cx="9179799" cy="1929068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619965" y="5099739"/>
            <a:ext cx="7559835" cy="229988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265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530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9795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0612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6326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9591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2857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6122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>
          <a:xfrm>
            <a:off x="7739833" y="8341242"/>
            <a:ext cx="2519944" cy="479142"/>
          </a:xfrm>
          <a:prstGeom prst="rect">
            <a:avLst/>
          </a:prstGeom>
        </p:spPr>
        <p:txBody>
          <a:bodyPr/>
          <a:lstStyle/>
          <a:p>
            <a:fld id="{C7EEFBFE-8DD2-4722-9615-FBDA36F903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>
          <a:xfrm>
            <a:off x="7739833" y="8341242"/>
            <a:ext cx="2519944" cy="479142"/>
          </a:xfrm>
          <a:prstGeom prst="rect">
            <a:avLst/>
          </a:prstGeom>
        </p:spPr>
        <p:txBody>
          <a:bodyPr/>
          <a:lstStyle/>
          <a:p>
            <a:fld id="{C7EEFBFE-8DD2-4722-9615-FBDA36F903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7829828" y="360404"/>
            <a:ext cx="2429947" cy="7678772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539988" y="360404"/>
            <a:ext cx="7109844" cy="7678772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>
          <a:xfrm>
            <a:off x="7739833" y="8341242"/>
            <a:ext cx="2519944" cy="479142"/>
          </a:xfrm>
          <a:prstGeom prst="rect">
            <a:avLst/>
          </a:prstGeom>
        </p:spPr>
        <p:txBody>
          <a:bodyPr/>
          <a:lstStyle/>
          <a:p>
            <a:fld id="{C7EEFBFE-8DD2-4722-9615-FBDA36F903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>
          <a:xfrm>
            <a:off x="7739833" y="8341242"/>
            <a:ext cx="2519944" cy="479142"/>
          </a:xfrm>
          <a:prstGeom prst="rect">
            <a:avLst/>
          </a:prstGeom>
        </p:spPr>
        <p:txBody>
          <a:bodyPr/>
          <a:lstStyle/>
          <a:p>
            <a:fld id="{C7EEFBFE-8DD2-4722-9615-FBDA36F903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53107" y="5783040"/>
            <a:ext cx="9179799" cy="1787409"/>
          </a:xfrm>
        </p:spPr>
        <p:txBody>
          <a:bodyPr anchor="t"/>
          <a:lstStyle>
            <a:lvl1pPr algn="l">
              <a:defRPr sz="2857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53107" y="3814391"/>
            <a:ext cx="9179799" cy="1968648"/>
          </a:xfrm>
        </p:spPr>
        <p:txBody>
          <a:bodyPr anchor="b"/>
          <a:lstStyle>
            <a:lvl1pPr marL="0" indent="0">
              <a:buNone/>
              <a:defRPr sz="1428">
                <a:solidFill>
                  <a:schemeClr val="tx1">
                    <a:tint val="75000"/>
                  </a:schemeClr>
                </a:solidFill>
              </a:defRPr>
            </a:lvl1pPr>
            <a:lvl2pPr marL="326532" indent="0">
              <a:buNone/>
              <a:defRPr sz="1286">
                <a:solidFill>
                  <a:schemeClr val="tx1">
                    <a:tint val="75000"/>
                  </a:schemeClr>
                </a:solidFill>
              </a:defRPr>
            </a:lvl2pPr>
            <a:lvl3pPr marL="653064" indent="0">
              <a:buNone/>
              <a:defRPr sz="1143">
                <a:solidFill>
                  <a:schemeClr val="tx1">
                    <a:tint val="75000"/>
                  </a:schemeClr>
                </a:solidFill>
              </a:defRPr>
            </a:lvl3pPr>
            <a:lvl4pPr marL="979597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4pPr>
            <a:lvl5pPr marL="1306129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5pPr>
            <a:lvl6pPr marL="1632661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6pPr>
            <a:lvl7pPr marL="1959193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7pPr>
            <a:lvl8pPr marL="2285726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8pPr>
            <a:lvl9pPr marL="2612258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>
          <a:xfrm>
            <a:off x="7739833" y="8341242"/>
            <a:ext cx="2519944" cy="479142"/>
          </a:xfrm>
          <a:prstGeom prst="rect">
            <a:avLst/>
          </a:prstGeom>
        </p:spPr>
        <p:txBody>
          <a:bodyPr/>
          <a:lstStyle/>
          <a:p>
            <a:fld id="{C7EEFBFE-8DD2-4722-9615-FBDA36F903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539989" y="2099896"/>
            <a:ext cx="4769895" cy="5939279"/>
          </a:xfrm>
        </p:spPr>
        <p:txBody>
          <a:bodyPr/>
          <a:lstStyle>
            <a:lvl1pPr>
              <a:defRPr sz="2000"/>
            </a:lvl1pPr>
            <a:lvl2pPr>
              <a:defRPr sz="1714"/>
            </a:lvl2pPr>
            <a:lvl3pPr>
              <a:defRPr sz="1428"/>
            </a:lvl3pPr>
            <a:lvl4pPr>
              <a:defRPr sz="1286"/>
            </a:lvl4pPr>
            <a:lvl5pPr>
              <a:defRPr sz="1286"/>
            </a:lvl5pPr>
            <a:lvl6pPr>
              <a:defRPr sz="1286"/>
            </a:lvl6pPr>
            <a:lvl7pPr>
              <a:defRPr sz="1286"/>
            </a:lvl7pPr>
            <a:lvl8pPr>
              <a:defRPr sz="1286"/>
            </a:lvl8pPr>
            <a:lvl9pPr>
              <a:defRPr sz="1286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5489881" y="2099896"/>
            <a:ext cx="4769895" cy="5939279"/>
          </a:xfrm>
        </p:spPr>
        <p:txBody>
          <a:bodyPr/>
          <a:lstStyle>
            <a:lvl1pPr>
              <a:defRPr sz="2000"/>
            </a:lvl1pPr>
            <a:lvl2pPr>
              <a:defRPr sz="1714"/>
            </a:lvl2pPr>
            <a:lvl3pPr>
              <a:defRPr sz="1428"/>
            </a:lvl3pPr>
            <a:lvl4pPr>
              <a:defRPr sz="1286"/>
            </a:lvl4pPr>
            <a:lvl5pPr>
              <a:defRPr sz="1286"/>
            </a:lvl5pPr>
            <a:lvl6pPr>
              <a:defRPr sz="1286"/>
            </a:lvl6pPr>
            <a:lvl7pPr>
              <a:defRPr sz="1286"/>
            </a:lvl7pPr>
            <a:lvl8pPr>
              <a:defRPr sz="1286"/>
            </a:lvl8pPr>
            <a:lvl9pPr>
              <a:defRPr sz="1286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>
          <a:xfrm>
            <a:off x="7739833" y="8341242"/>
            <a:ext cx="2519944" cy="479142"/>
          </a:xfrm>
          <a:prstGeom prst="rect">
            <a:avLst/>
          </a:prstGeom>
        </p:spPr>
        <p:txBody>
          <a:bodyPr/>
          <a:lstStyle/>
          <a:p>
            <a:fld id="{C7EEFBFE-8DD2-4722-9615-FBDA36F903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39990" y="2014483"/>
            <a:ext cx="4771771" cy="839540"/>
          </a:xfrm>
        </p:spPr>
        <p:txBody>
          <a:bodyPr anchor="b"/>
          <a:lstStyle>
            <a:lvl1pPr marL="0" indent="0">
              <a:buNone/>
              <a:defRPr sz="1714" b="1"/>
            </a:lvl1pPr>
            <a:lvl2pPr marL="326532" indent="0">
              <a:buNone/>
              <a:defRPr sz="1428" b="1"/>
            </a:lvl2pPr>
            <a:lvl3pPr marL="653064" indent="0">
              <a:buNone/>
              <a:defRPr sz="1286" b="1"/>
            </a:lvl3pPr>
            <a:lvl4pPr marL="979597" indent="0">
              <a:buNone/>
              <a:defRPr sz="1143" b="1"/>
            </a:lvl4pPr>
            <a:lvl5pPr marL="1306129" indent="0">
              <a:buNone/>
              <a:defRPr sz="1143" b="1"/>
            </a:lvl5pPr>
            <a:lvl6pPr marL="1632661" indent="0">
              <a:buNone/>
              <a:defRPr sz="1143" b="1"/>
            </a:lvl6pPr>
            <a:lvl7pPr marL="1959193" indent="0">
              <a:buNone/>
              <a:defRPr sz="1143" b="1"/>
            </a:lvl7pPr>
            <a:lvl8pPr marL="2285726" indent="0">
              <a:buNone/>
              <a:defRPr sz="1143" b="1"/>
            </a:lvl8pPr>
            <a:lvl9pPr marL="2612258" indent="0">
              <a:buNone/>
              <a:defRPr sz="1143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539990" y="2854022"/>
            <a:ext cx="4771771" cy="5185151"/>
          </a:xfrm>
        </p:spPr>
        <p:txBody>
          <a:bodyPr/>
          <a:lstStyle>
            <a:lvl1pPr>
              <a:defRPr sz="1714"/>
            </a:lvl1pPr>
            <a:lvl2pPr>
              <a:defRPr sz="1428"/>
            </a:lvl2pPr>
            <a:lvl3pPr>
              <a:defRPr sz="1286"/>
            </a:lvl3pPr>
            <a:lvl4pPr>
              <a:defRPr sz="1143"/>
            </a:lvl4pPr>
            <a:lvl5pPr>
              <a:defRPr sz="1143"/>
            </a:lvl5pPr>
            <a:lvl6pPr>
              <a:defRPr sz="1143"/>
            </a:lvl6pPr>
            <a:lvl7pPr>
              <a:defRPr sz="1143"/>
            </a:lvl7pPr>
            <a:lvl8pPr>
              <a:defRPr sz="1143"/>
            </a:lvl8pPr>
            <a:lvl9pPr>
              <a:defRPr sz="1143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5486133" y="2014483"/>
            <a:ext cx="4773645" cy="839540"/>
          </a:xfrm>
        </p:spPr>
        <p:txBody>
          <a:bodyPr anchor="b"/>
          <a:lstStyle>
            <a:lvl1pPr marL="0" indent="0">
              <a:buNone/>
              <a:defRPr sz="1714" b="1"/>
            </a:lvl1pPr>
            <a:lvl2pPr marL="326532" indent="0">
              <a:buNone/>
              <a:defRPr sz="1428" b="1"/>
            </a:lvl2pPr>
            <a:lvl3pPr marL="653064" indent="0">
              <a:buNone/>
              <a:defRPr sz="1286" b="1"/>
            </a:lvl3pPr>
            <a:lvl4pPr marL="979597" indent="0">
              <a:buNone/>
              <a:defRPr sz="1143" b="1"/>
            </a:lvl4pPr>
            <a:lvl5pPr marL="1306129" indent="0">
              <a:buNone/>
              <a:defRPr sz="1143" b="1"/>
            </a:lvl5pPr>
            <a:lvl6pPr marL="1632661" indent="0">
              <a:buNone/>
              <a:defRPr sz="1143" b="1"/>
            </a:lvl6pPr>
            <a:lvl7pPr marL="1959193" indent="0">
              <a:buNone/>
              <a:defRPr sz="1143" b="1"/>
            </a:lvl7pPr>
            <a:lvl8pPr marL="2285726" indent="0">
              <a:buNone/>
              <a:defRPr sz="1143" b="1"/>
            </a:lvl8pPr>
            <a:lvl9pPr marL="2612258" indent="0">
              <a:buNone/>
              <a:defRPr sz="1143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5486133" y="2854022"/>
            <a:ext cx="4773645" cy="5185151"/>
          </a:xfrm>
        </p:spPr>
        <p:txBody>
          <a:bodyPr/>
          <a:lstStyle>
            <a:lvl1pPr>
              <a:defRPr sz="1714"/>
            </a:lvl1pPr>
            <a:lvl2pPr>
              <a:defRPr sz="1428"/>
            </a:lvl2pPr>
            <a:lvl3pPr>
              <a:defRPr sz="1286"/>
            </a:lvl3pPr>
            <a:lvl4pPr>
              <a:defRPr sz="1143"/>
            </a:lvl4pPr>
            <a:lvl5pPr>
              <a:defRPr sz="1143"/>
            </a:lvl5pPr>
            <a:lvl6pPr>
              <a:defRPr sz="1143"/>
            </a:lvl6pPr>
            <a:lvl7pPr>
              <a:defRPr sz="1143"/>
            </a:lvl7pPr>
            <a:lvl8pPr>
              <a:defRPr sz="1143"/>
            </a:lvl8pPr>
            <a:lvl9pPr>
              <a:defRPr sz="1143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>
          <a:xfrm>
            <a:off x="7739833" y="8341242"/>
            <a:ext cx="2519944" cy="479142"/>
          </a:xfrm>
          <a:prstGeom prst="rect">
            <a:avLst/>
          </a:prstGeom>
        </p:spPr>
        <p:txBody>
          <a:bodyPr/>
          <a:lstStyle/>
          <a:p>
            <a:fld id="{C7EEFBFE-8DD2-4722-9615-FBDA36F903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>
          <a:xfrm>
            <a:off x="7739833" y="8341242"/>
            <a:ext cx="2519944" cy="479142"/>
          </a:xfrm>
          <a:prstGeom prst="rect">
            <a:avLst/>
          </a:prstGeom>
        </p:spPr>
        <p:txBody>
          <a:bodyPr/>
          <a:lstStyle/>
          <a:p>
            <a:fld id="{C7EEFBFE-8DD2-4722-9615-FBDA36F903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>
          <a:xfrm>
            <a:off x="7739833" y="8341242"/>
            <a:ext cx="2519944" cy="479142"/>
          </a:xfrm>
          <a:prstGeom prst="rect">
            <a:avLst/>
          </a:prstGeom>
        </p:spPr>
        <p:txBody>
          <a:bodyPr/>
          <a:lstStyle/>
          <a:p>
            <a:fld id="{C7EEFBFE-8DD2-4722-9615-FBDA36F903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39991" y="358315"/>
            <a:ext cx="3553048" cy="1524922"/>
          </a:xfrm>
        </p:spPr>
        <p:txBody>
          <a:bodyPr anchor="b"/>
          <a:lstStyle>
            <a:lvl1pPr algn="l">
              <a:defRPr sz="1428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222408" y="358320"/>
            <a:ext cx="6037367" cy="7680857"/>
          </a:xfrm>
        </p:spPr>
        <p:txBody>
          <a:bodyPr/>
          <a:lstStyle>
            <a:lvl1pPr>
              <a:defRPr sz="2285"/>
            </a:lvl1pPr>
            <a:lvl2pPr>
              <a:defRPr sz="2000"/>
            </a:lvl2pPr>
            <a:lvl3pPr>
              <a:defRPr sz="1714"/>
            </a:lvl3pPr>
            <a:lvl4pPr>
              <a:defRPr sz="1428"/>
            </a:lvl4pPr>
            <a:lvl5pPr>
              <a:defRPr sz="1428"/>
            </a:lvl5pPr>
            <a:lvl6pPr>
              <a:defRPr sz="1428"/>
            </a:lvl6pPr>
            <a:lvl7pPr>
              <a:defRPr sz="1428"/>
            </a:lvl7pPr>
            <a:lvl8pPr>
              <a:defRPr sz="1428"/>
            </a:lvl8pPr>
            <a:lvl9pPr>
              <a:defRPr sz="1428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539991" y="1883240"/>
            <a:ext cx="3553048" cy="6155935"/>
          </a:xfrm>
        </p:spPr>
        <p:txBody>
          <a:bodyPr/>
          <a:lstStyle>
            <a:lvl1pPr marL="0" indent="0">
              <a:buNone/>
              <a:defRPr sz="1000"/>
            </a:lvl1pPr>
            <a:lvl2pPr marL="326532" indent="0">
              <a:buNone/>
              <a:defRPr sz="857"/>
            </a:lvl2pPr>
            <a:lvl3pPr marL="653064" indent="0">
              <a:buNone/>
              <a:defRPr sz="714"/>
            </a:lvl3pPr>
            <a:lvl4pPr marL="979597" indent="0">
              <a:buNone/>
              <a:defRPr sz="643"/>
            </a:lvl4pPr>
            <a:lvl5pPr marL="1306129" indent="0">
              <a:buNone/>
              <a:defRPr sz="643"/>
            </a:lvl5pPr>
            <a:lvl6pPr marL="1632661" indent="0">
              <a:buNone/>
              <a:defRPr sz="643"/>
            </a:lvl6pPr>
            <a:lvl7pPr marL="1959193" indent="0">
              <a:buNone/>
              <a:defRPr sz="643"/>
            </a:lvl7pPr>
            <a:lvl8pPr marL="2285726" indent="0">
              <a:buNone/>
              <a:defRPr sz="643"/>
            </a:lvl8pPr>
            <a:lvl9pPr marL="2612258" indent="0">
              <a:buNone/>
              <a:defRPr sz="643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>
          <a:xfrm>
            <a:off x="7739833" y="8341242"/>
            <a:ext cx="2519944" cy="479142"/>
          </a:xfrm>
          <a:prstGeom prst="rect">
            <a:avLst/>
          </a:prstGeom>
        </p:spPr>
        <p:txBody>
          <a:bodyPr/>
          <a:lstStyle/>
          <a:p>
            <a:fld id="{C7EEFBFE-8DD2-4722-9615-FBDA36F903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116830" y="6299677"/>
            <a:ext cx="6479858" cy="743713"/>
          </a:xfrm>
        </p:spPr>
        <p:txBody>
          <a:bodyPr anchor="b"/>
          <a:lstStyle>
            <a:lvl1pPr algn="l">
              <a:defRPr sz="1428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116830" y="804127"/>
            <a:ext cx="6479858" cy="5399723"/>
          </a:xfrm>
        </p:spPr>
        <p:txBody>
          <a:bodyPr/>
          <a:lstStyle>
            <a:lvl1pPr marL="0" indent="0">
              <a:buNone/>
              <a:defRPr sz="2285"/>
            </a:lvl1pPr>
            <a:lvl2pPr marL="326532" indent="0">
              <a:buNone/>
              <a:defRPr sz="2000"/>
            </a:lvl2pPr>
            <a:lvl3pPr marL="653064" indent="0">
              <a:buNone/>
              <a:defRPr sz="1714"/>
            </a:lvl3pPr>
            <a:lvl4pPr marL="979597" indent="0">
              <a:buNone/>
              <a:defRPr sz="1428"/>
            </a:lvl4pPr>
            <a:lvl5pPr marL="1306129" indent="0">
              <a:buNone/>
              <a:defRPr sz="1428"/>
            </a:lvl5pPr>
            <a:lvl6pPr marL="1632661" indent="0">
              <a:buNone/>
              <a:defRPr sz="1428"/>
            </a:lvl6pPr>
            <a:lvl7pPr marL="1959193" indent="0">
              <a:buNone/>
              <a:defRPr sz="1428"/>
            </a:lvl7pPr>
            <a:lvl8pPr marL="2285726" indent="0">
              <a:buNone/>
              <a:defRPr sz="1428"/>
            </a:lvl8pPr>
            <a:lvl9pPr marL="2612258" indent="0">
              <a:buNone/>
              <a:defRPr sz="1428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116830" y="7043392"/>
            <a:ext cx="6479858" cy="1056195"/>
          </a:xfrm>
        </p:spPr>
        <p:txBody>
          <a:bodyPr/>
          <a:lstStyle>
            <a:lvl1pPr marL="0" indent="0">
              <a:buNone/>
              <a:defRPr sz="1000"/>
            </a:lvl1pPr>
            <a:lvl2pPr marL="326532" indent="0">
              <a:buNone/>
              <a:defRPr sz="857"/>
            </a:lvl2pPr>
            <a:lvl3pPr marL="653064" indent="0">
              <a:buNone/>
              <a:defRPr sz="714"/>
            </a:lvl3pPr>
            <a:lvl4pPr marL="979597" indent="0">
              <a:buNone/>
              <a:defRPr sz="643"/>
            </a:lvl4pPr>
            <a:lvl5pPr marL="1306129" indent="0">
              <a:buNone/>
              <a:defRPr sz="643"/>
            </a:lvl5pPr>
            <a:lvl6pPr marL="1632661" indent="0">
              <a:buNone/>
              <a:defRPr sz="643"/>
            </a:lvl6pPr>
            <a:lvl7pPr marL="1959193" indent="0">
              <a:buNone/>
              <a:defRPr sz="643"/>
            </a:lvl7pPr>
            <a:lvl8pPr marL="2285726" indent="0">
              <a:buNone/>
              <a:defRPr sz="643"/>
            </a:lvl8pPr>
            <a:lvl9pPr marL="2612258" indent="0">
              <a:buNone/>
              <a:defRPr sz="643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>
          <a:xfrm>
            <a:off x="7739833" y="8341242"/>
            <a:ext cx="2519944" cy="479142"/>
          </a:xfrm>
          <a:prstGeom prst="rect">
            <a:avLst/>
          </a:prstGeom>
        </p:spPr>
        <p:txBody>
          <a:bodyPr/>
          <a:lstStyle/>
          <a:p>
            <a:fld id="{C7EEFBFE-8DD2-4722-9615-FBDA36F903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539991" y="360401"/>
            <a:ext cx="9719786" cy="149992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39991" y="2099896"/>
            <a:ext cx="9719786" cy="59392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539991" y="8341242"/>
            <a:ext cx="2519944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689920" y="8341242"/>
            <a:ext cx="3419925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7" name="슬라이드 번호 개체 틀 5"/>
          <p:cNvSpPr txBox="1">
            <a:spLocks/>
          </p:cNvSpPr>
          <p:nvPr/>
        </p:nvSpPr>
        <p:spPr>
          <a:xfrm>
            <a:off x="212019" y="8517339"/>
            <a:ext cx="2278092" cy="329148"/>
          </a:xfrm>
          <a:prstGeom prst="rect">
            <a:avLst/>
          </a:prstGeom>
        </p:spPr>
        <p:txBody>
          <a:bodyPr vert="horz" lIns="65311" tIns="32655" rIns="65311" bIns="32655" rtlCol="0" anchor="ctr"/>
          <a:lstStyle>
            <a:lvl1pPr algn="l">
              <a:defRPr sz="1800">
                <a:solidFill>
                  <a:schemeClr val="bg1"/>
                </a:solidFill>
                <a:latin typeface="PF Din Text Cond Pro Medium" pitchFamily="2" charset="0"/>
                <a:ea typeface="Rix고딕 M" pitchFamily="18" charset="-127"/>
              </a:defRPr>
            </a:lvl1pPr>
          </a:lstStyle>
          <a:p>
            <a:pPr algn="l">
              <a:defRPr/>
            </a:pPr>
            <a:fld id="{EC0BB0C5-6955-4F9B-BA60-58E2367A55EF}" type="slidenum">
              <a:rPr lang="ko-KR" altLang="en-US" sz="607" smtClean="0">
                <a:solidFill>
                  <a:schemeClr val="tx1">
                    <a:lumMod val="50000"/>
                    <a:lumOff val="50000"/>
                  </a:schemeClr>
                </a:solidFill>
                <a:latin typeface="나눔바른고딕" pitchFamily="50" charset="-127"/>
                <a:ea typeface="나눔바른고딕" pitchFamily="50" charset="-127"/>
              </a:rPr>
              <a:pPr algn="l">
                <a:defRPr/>
              </a:pPr>
              <a:t>‹#›</a:t>
            </a:fld>
            <a:endParaRPr lang="ko-KR" altLang="en-US" sz="571" dirty="0">
              <a:solidFill>
                <a:schemeClr val="tx1">
                  <a:lumMod val="50000"/>
                  <a:lumOff val="50000"/>
                </a:schemeClr>
              </a:solidFill>
              <a:latin typeface="나눔바른고딕" pitchFamily="50" charset="-127"/>
              <a:ea typeface="나눔바른고딕" pitchFamily="50" charset="-127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653064" rtl="0" eaLnBrk="1" latinLnBrk="1" hangingPunct="1">
        <a:spcBef>
          <a:spcPct val="0"/>
        </a:spcBef>
        <a:buNone/>
        <a:defRPr sz="314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4899" indent="-244899" algn="l" defTabSz="653064" rtl="0" eaLnBrk="1" latinLnBrk="1" hangingPunct="1">
        <a:spcBef>
          <a:spcPct val="20000"/>
        </a:spcBef>
        <a:buFont typeface="Arial" pitchFamily="34" charset="0"/>
        <a:buChar char="•"/>
        <a:defRPr sz="2285" kern="1200">
          <a:solidFill>
            <a:schemeClr val="tx1"/>
          </a:solidFill>
          <a:latin typeface="+mn-lt"/>
          <a:ea typeface="+mn-ea"/>
          <a:cs typeface="+mn-cs"/>
        </a:defRPr>
      </a:lvl1pPr>
      <a:lvl2pPr marL="530615" indent="-204083" algn="l" defTabSz="653064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816331" indent="-163266" algn="l" defTabSz="653064" rtl="0" eaLnBrk="1" latinLnBrk="1" hangingPunct="1">
        <a:spcBef>
          <a:spcPct val="20000"/>
        </a:spcBef>
        <a:buFont typeface="Arial" pitchFamily="34" charset="0"/>
        <a:buChar char="•"/>
        <a:defRPr sz="1714" kern="1200">
          <a:solidFill>
            <a:schemeClr val="tx1"/>
          </a:solidFill>
          <a:latin typeface="+mn-lt"/>
          <a:ea typeface="+mn-ea"/>
          <a:cs typeface="+mn-cs"/>
        </a:defRPr>
      </a:lvl3pPr>
      <a:lvl4pPr marL="1142863" indent="-163266" algn="l" defTabSz="653064" rtl="0" eaLnBrk="1" latinLnBrk="1" hangingPunct="1">
        <a:spcBef>
          <a:spcPct val="20000"/>
        </a:spcBef>
        <a:buFont typeface="Arial" pitchFamily="34" charset="0"/>
        <a:buChar char="–"/>
        <a:defRPr sz="1428" kern="1200">
          <a:solidFill>
            <a:schemeClr val="tx1"/>
          </a:solidFill>
          <a:latin typeface="+mn-lt"/>
          <a:ea typeface="+mn-ea"/>
          <a:cs typeface="+mn-cs"/>
        </a:defRPr>
      </a:lvl4pPr>
      <a:lvl5pPr marL="1469395" indent="-163266" algn="l" defTabSz="653064" rtl="0" eaLnBrk="1" latinLnBrk="1" hangingPunct="1">
        <a:spcBef>
          <a:spcPct val="20000"/>
        </a:spcBef>
        <a:buFont typeface="Arial" pitchFamily="34" charset="0"/>
        <a:buChar char="»"/>
        <a:defRPr sz="1428" kern="1200">
          <a:solidFill>
            <a:schemeClr val="tx1"/>
          </a:solidFill>
          <a:latin typeface="+mn-lt"/>
          <a:ea typeface="+mn-ea"/>
          <a:cs typeface="+mn-cs"/>
        </a:defRPr>
      </a:lvl5pPr>
      <a:lvl6pPr marL="1795927" indent="-163266" algn="l" defTabSz="653064" rtl="0" eaLnBrk="1" latinLnBrk="1" hangingPunct="1">
        <a:spcBef>
          <a:spcPct val="20000"/>
        </a:spcBef>
        <a:buFont typeface="Arial" pitchFamily="34" charset="0"/>
        <a:buChar char="•"/>
        <a:defRPr sz="1428" kern="1200">
          <a:solidFill>
            <a:schemeClr val="tx1"/>
          </a:solidFill>
          <a:latin typeface="+mn-lt"/>
          <a:ea typeface="+mn-ea"/>
          <a:cs typeface="+mn-cs"/>
        </a:defRPr>
      </a:lvl6pPr>
      <a:lvl7pPr marL="2122460" indent="-163266" algn="l" defTabSz="653064" rtl="0" eaLnBrk="1" latinLnBrk="1" hangingPunct="1">
        <a:spcBef>
          <a:spcPct val="20000"/>
        </a:spcBef>
        <a:buFont typeface="Arial" pitchFamily="34" charset="0"/>
        <a:buChar char="•"/>
        <a:defRPr sz="1428" kern="1200">
          <a:solidFill>
            <a:schemeClr val="tx1"/>
          </a:solidFill>
          <a:latin typeface="+mn-lt"/>
          <a:ea typeface="+mn-ea"/>
          <a:cs typeface="+mn-cs"/>
        </a:defRPr>
      </a:lvl7pPr>
      <a:lvl8pPr marL="2448992" indent="-163266" algn="l" defTabSz="653064" rtl="0" eaLnBrk="1" latinLnBrk="1" hangingPunct="1">
        <a:spcBef>
          <a:spcPct val="20000"/>
        </a:spcBef>
        <a:buFont typeface="Arial" pitchFamily="34" charset="0"/>
        <a:buChar char="•"/>
        <a:defRPr sz="1428" kern="1200">
          <a:solidFill>
            <a:schemeClr val="tx1"/>
          </a:solidFill>
          <a:latin typeface="+mn-lt"/>
          <a:ea typeface="+mn-ea"/>
          <a:cs typeface="+mn-cs"/>
        </a:defRPr>
      </a:lvl8pPr>
      <a:lvl9pPr marL="2775524" indent="-163266" algn="l" defTabSz="653064" rtl="0" eaLnBrk="1" latinLnBrk="1" hangingPunct="1">
        <a:spcBef>
          <a:spcPct val="20000"/>
        </a:spcBef>
        <a:buFont typeface="Arial" pitchFamily="34" charset="0"/>
        <a:buChar char="•"/>
        <a:defRPr sz="142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653064" rtl="0" eaLnBrk="1" latinLnBrk="1" hangingPunct="1">
        <a:defRPr sz="1286" kern="1200">
          <a:solidFill>
            <a:schemeClr val="tx1"/>
          </a:solidFill>
          <a:latin typeface="+mn-lt"/>
          <a:ea typeface="+mn-ea"/>
          <a:cs typeface="+mn-cs"/>
        </a:defRPr>
      </a:lvl1pPr>
      <a:lvl2pPr marL="326532" algn="l" defTabSz="653064" rtl="0" eaLnBrk="1" latinLnBrk="1" hangingPunct="1">
        <a:defRPr sz="1286" kern="1200">
          <a:solidFill>
            <a:schemeClr val="tx1"/>
          </a:solidFill>
          <a:latin typeface="+mn-lt"/>
          <a:ea typeface="+mn-ea"/>
          <a:cs typeface="+mn-cs"/>
        </a:defRPr>
      </a:lvl2pPr>
      <a:lvl3pPr marL="653064" algn="l" defTabSz="653064" rtl="0" eaLnBrk="1" latinLnBrk="1" hangingPunct="1">
        <a:defRPr sz="1286" kern="1200">
          <a:solidFill>
            <a:schemeClr val="tx1"/>
          </a:solidFill>
          <a:latin typeface="+mn-lt"/>
          <a:ea typeface="+mn-ea"/>
          <a:cs typeface="+mn-cs"/>
        </a:defRPr>
      </a:lvl3pPr>
      <a:lvl4pPr marL="979597" algn="l" defTabSz="653064" rtl="0" eaLnBrk="1" latinLnBrk="1" hangingPunct="1">
        <a:defRPr sz="1286" kern="1200">
          <a:solidFill>
            <a:schemeClr val="tx1"/>
          </a:solidFill>
          <a:latin typeface="+mn-lt"/>
          <a:ea typeface="+mn-ea"/>
          <a:cs typeface="+mn-cs"/>
        </a:defRPr>
      </a:lvl4pPr>
      <a:lvl5pPr marL="1306129" algn="l" defTabSz="653064" rtl="0" eaLnBrk="1" latinLnBrk="1" hangingPunct="1">
        <a:defRPr sz="1286" kern="1200">
          <a:solidFill>
            <a:schemeClr val="tx1"/>
          </a:solidFill>
          <a:latin typeface="+mn-lt"/>
          <a:ea typeface="+mn-ea"/>
          <a:cs typeface="+mn-cs"/>
        </a:defRPr>
      </a:lvl5pPr>
      <a:lvl6pPr marL="1632661" algn="l" defTabSz="653064" rtl="0" eaLnBrk="1" latinLnBrk="1" hangingPunct="1">
        <a:defRPr sz="1286" kern="1200">
          <a:solidFill>
            <a:schemeClr val="tx1"/>
          </a:solidFill>
          <a:latin typeface="+mn-lt"/>
          <a:ea typeface="+mn-ea"/>
          <a:cs typeface="+mn-cs"/>
        </a:defRPr>
      </a:lvl6pPr>
      <a:lvl7pPr marL="1959193" algn="l" defTabSz="653064" rtl="0" eaLnBrk="1" latinLnBrk="1" hangingPunct="1">
        <a:defRPr sz="1286" kern="1200">
          <a:solidFill>
            <a:schemeClr val="tx1"/>
          </a:solidFill>
          <a:latin typeface="+mn-lt"/>
          <a:ea typeface="+mn-ea"/>
          <a:cs typeface="+mn-cs"/>
        </a:defRPr>
      </a:lvl7pPr>
      <a:lvl8pPr marL="2285726" algn="l" defTabSz="653064" rtl="0" eaLnBrk="1" latinLnBrk="1" hangingPunct="1">
        <a:defRPr sz="1286" kern="1200">
          <a:solidFill>
            <a:schemeClr val="tx1"/>
          </a:solidFill>
          <a:latin typeface="+mn-lt"/>
          <a:ea typeface="+mn-ea"/>
          <a:cs typeface="+mn-cs"/>
        </a:defRPr>
      </a:lvl8pPr>
      <a:lvl9pPr marL="2612258" algn="l" defTabSz="653064" rtl="0" eaLnBrk="1" latinLnBrk="1" hangingPunct="1">
        <a:defRPr sz="128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935385" y="559924"/>
            <a:ext cx="6531099" cy="263790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ko-KR" sz="1714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ble S1. </a:t>
            </a:r>
            <a:r>
              <a:rPr lang="en-US" altLang="ko-KR" sz="1714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ried yields of 5 extracts from </a:t>
            </a:r>
            <a:r>
              <a:rPr lang="en-US" altLang="ko-KR" sz="1714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firma</a:t>
            </a:r>
            <a:r>
              <a:rPr lang="en-US" altLang="ko-KR" sz="1714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en-US" sz="1714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표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88116404"/>
              </p:ext>
            </p:extLst>
          </p:nvPr>
        </p:nvGraphicFramePr>
        <p:xfrm>
          <a:off x="935385" y="971377"/>
          <a:ext cx="5049657" cy="3240195"/>
        </p:xfrm>
        <a:graphic>
          <a:graphicData uri="http://schemas.openxmlformats.org/drawingml/2006/table">
            <a:tbl>
              <a:tblPr/>
              <a:tblGrid>
                <a:gridCol w="196103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57582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51279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46288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olvent</a:t>
                      </a:r>
                    </a:p>
                  </a:txBody>
                  <a:tcPr marL="21040" marR="21040" marT="210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Weight (g)</a:t>
                      </a:r>
                    </a:p>
                  </a:txBody>
                  <a:tcPr marL="21040" marR="21040" marT="210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Yield (%)</a:t>
                      </a:r>
                    </a:p>
                  </a:txBody>
                  <a:tcPr marL="21040" marR="21040" marT="210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6288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% methanol</a:t>
                      </a:r>
                    </a:p>
                  </a:txBody>
                  <a:tcPr marL="21040" marR="21040" marT="210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5901</a:t>
                      </a:r>
                    </a:p>
                  </a:txBody>
                  <a:tcPr marL="21040" marR="21040" marT="210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9.01</a:t>
                      </a:r>
                    </a:p>
                  </a:txBody>
                  <a:tcPr marL="21040" marR="21040" marT="210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6288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0% </a:t>
                      </a:r>
                      <a:r>
                        <a:rPr lang="en-US" altLang="ko-KR" sz="1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methanol</a:t>
                      </a:r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21040" marR="21040" marT="210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1051</a:t>
                      </a:r>
                    </a:p>
                  </a:txBody>
                  <a:tcPr marL="21040" marR="21040" marT="210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0.51</a:t>
                      </a:r>
                    </a:p>
                  </a:txBody>
                  <a:tcPr marL="21040" marR="21040" marT="210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6288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60% </a:t>
                      </a:r>
                      <a:r>
                        <a:rPr lang="en-US" altLang="ko-KR" sz="1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methanol</a:t>
                      </a:r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21040" marR="21040" marT="210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722</a:t>
                      </a:r>
                    </a:p>
                  </a:txBody>
                  <a:tcPr marL="21040" marR="21040" marT="210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7.22</a:t>
                      </a:r>
                    </a:p>
                  </a:txBody>
                  <a:tcPr marL="21040" marR="21040" marT="210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6288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0% </a:t>
                      </a:r>
                      <a:r>
                        <a:rPr lang="en-US" altLang="ko-KR" sz="1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methanol</a:t>
                      </a:r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21040" marR="21040" marT="210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293</a:t>
                      </a:r>
                    </a:p>
                  </a:txBody>
                  <a:tcPr marL="21040" marR="21040" marT="210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.93</a:t>
                      </a:r>
                    </a:p>
                  </a:txBody>
                  <a:tcPr marL="21040" marR="21040" marT="210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6288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00% </a:t>
                      </a:r>
                      <a:r>
                        <a:rPr lang="en-US" altLang="ko-KR" sz="1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methanol</a:t>
                      </a:r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21040" marR="21040" marT="210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446</a:t>
                      </a:r>
                    </a:p>
                  </a:txBody>
                  <a:tcPr marL="21040" marR="21040" marT="210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.46</a:t>
                      </a:r>
                    </a:p>
                  </a:txBody>
                  <a:tcPr marL="21040" marR="21040" marT="210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6288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um</a:t>
                      </a:r>
                    </a:p>
                  </a:txBody>
                  <a:tcPr marL="21040" marR="21040" marT="210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8413</a:t>
                      </a:r>
                    </a:p>
                  </a:txBody>
                  <a:tcPr marL="21040" marR="21040" marT="210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4.13</a:t>
                      </a:r>
                    </a:p>
                  </a:txBody>
                  <a:tcPr marL="21040" marR="21040" marT="210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249266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/>
          <p:cNvSpPr txBox="1"/>
          <p:nvPr/>
        </p:nvSpPr>
        <p:spPr>
          <a:xfrm>
            <a:off x="739336" y="179289"/>
            <a:ext cx="9145016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just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.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ntatively identified metabolites in 5 SPE extracts based on metabolite profiling combined with multivariate statistical analysis.</a:t>
            </a:r>
            <a:endParaRPr lang="ko-KR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739336" y="8569384"/>
            <a:ext cx="9327794" cy="41120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just" latinLnBrk="0">
              <a:lnSpc>
                <a:spcPts val="1700"/>
              </a:lnSpc>
              <a:spcAft>
                <a:spcPts val="0"/>
              </a:spcAft>
            </a:pPr>
            <a:r>
              <a:rPr lang="en-US" altLang="ko-KR" sz="10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ko-KR" sz="10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utative metabolites based on VIP &gt; 0.7 and </a:t>
            </a:r>
            <a:r>
              <a:rPr lang="en-US" altLang="ko-KR" sz="1000" i="1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0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value &lt; 0.05. </a:t>
            </a:r>
            <a:r>
              <a:rPr lang="en-US" altLang="ko-KR" sz="10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ko-KR" sz="10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Retention time. </a:t>
            </a:r>
            <a:r>
              <a:rPr lang="en-US" altLang="ko-KR" sz="10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ko-KR" sz="10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on detected in negative mode. </a:t>
            </a:r>
            <a:r>
              <a:rPr lang="en-US" altLang="ko-KR" sz="10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ko-KR" sz="10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on detected in positive mode. </a:t>
            </a:r>
            <a:r>
              <a:rPr lang="en-US" altLang="ko-KR" sz="10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ko-KR" sz="10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olecular weight. </a:t>
            </a:r>
            <a:r>
              <a:rPr lang="en-US" altLang="ko-KR" sz="10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altLang="ko-KR" sz="10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kern="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S</a:t>
            </a:r>
            <a:r>
              <a:rPr lang="en-US" altLang="ko-KR" sz="1000" kern="100" baseline="300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ko-KR" sz="10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fragment patterns detected in positive mode. </a:t>
            </a:r>
            <a:r>
              <a:rPr lang="en-US" altLang="ko-KR" sz="10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ko-KR" sz="10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dentification</a:t>
            </a:r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graphicFrame>
        <p:nvGraphicFramePr>
          <p:cNvPr id="2" name="표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08133680"/>
              </p:ext>
            </p:extLst>
          </p:nvPr>
        </p:nvGraphicFramePr>
        <p:xfrm>
          <a:off x="739336" y="609866"/>
          <a:ext cx="8981025" cy="7949980"/>
        </p:xfrm>
        <a:graphic>
          <a:graphicData uri="http://schemas.openxmlformats.org/drawingml/2006/table">
            <a:tbl>
              <a:tblPr/>
              <a:tblGrid>
                <a:gridCol w="58441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1994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6004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9208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9208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3204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08012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648072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576064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720080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576064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</a:tblGrid>
              <a:tr h="122357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o.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utativ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dentification</a:t>
                      </a:r>
                      <a:r>
                        <a:rPr lang="en-US" sz="800" b="0" i="0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</a:t>
                      </a:r>
                      <a:endParaRPr lang="en-US" sz="8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6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TQ-IT-MS/MS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tatistics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D</a:t>
                      </a:r>
                      <a:r>
                        <a:rPr lang="en-US" sz="800" b="0" i="0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</a:t>
                      </a:r>
                      <a:endParaRPr lang="en-US" sz="8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91543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RT</a:t>
                      </a:r>
                      <a:r>
                        <a:rPr lang="en-US" sz="800" b="0" i="0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b</a:t>
                      </a:r>
                      <a:b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</a:b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(min)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m/z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ega</a:t>
                      </a:r>
                      <a:r>
                        <a:rPr lang="en-US" sz="800" b="0" i="0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</a:t>
                      </a:r>
                      <a:endParaRPr lang="en-US" sz="8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m/z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osi</a:t>
                      </a:r>
                      <a:r>
                        <a:rPr lang="en-US" sz="800" b="0" i="0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d</a:t>
                      </a:r>
                      <a:endParaRPr lang="en-US" sz="8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M.W.</a:t>
                      </a:r>
                      <a:r>
                        <a:rPr lang="en-US" sz="800" b="0" i="0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e</a:t>
                      </a:r>
                      <a:endParaRPr lang="en-US" sz="8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MS</a:t>
                      </a:r>
                      <a:r>
                        <a:rPr lang="en-US" sz="800" b="0" i="0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 Fragment Pattern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UV</a:t>
                      </a:r>
                      <a:b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</a:b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(nm)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VIP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-value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Ethyl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allat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6.72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9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99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98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59 [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osi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]</a:t>
                      </a:r>
                      <a:r>
                        <a:rPr lang="en-US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f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1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372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TD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Myricetin-3-O-galactoside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7.03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79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8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8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19 [posi]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15, 35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351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TD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.I. 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7.24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4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45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44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69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4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333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Quercetin-3-O-rutinoside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7.43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609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61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61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03 [posi]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5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85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TD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Myricetin-3-O-pentoside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7.44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49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5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5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19 [posi]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18, 355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300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Mass bank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6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Quercetin-3-O-glucoside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7.57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6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65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64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01 &gt; 179, 15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7, 255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246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9.00E-04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TD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Ellagic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 acid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7.72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0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0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02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57, 229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53, 366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61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TD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.I. 2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7.72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1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15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14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1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351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9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Quercetin-3-O-glucuronide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7.73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7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79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78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0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349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TD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Kaempferol-3-O-rutinoside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7.93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9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95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94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49, 287 [posi]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96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TD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Hirsutosid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.02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9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9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92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1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349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CD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2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Quercetin-3-O-arabinoside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.03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3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35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34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03 [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osi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]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12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93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TD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.I. 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.03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3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338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4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uteolin-7-O-glucuronide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.22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6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6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62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85, 26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354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TD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5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Quercetin-3-O-rhamnoside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.24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4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49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48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03 [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osi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]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56, 348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86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TD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6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inosylvin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diglucosid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.27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81[M+FA]</a:t>
                      </a:r>
                      <a:r>
                        <a:rPr lang="en-US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3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36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75 &gt; 213 [posi]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14, 274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335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CD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.I. 4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.36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8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95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8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.I. 5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.45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2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2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22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75 &gt; 295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66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85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9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.I. 6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.47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25[M+FA]</a:t>
                      </a:r>
                      <a:r>
                        <a:rPr lang="en-US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03[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M+Na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]</a:t>
                      </a:r>
                      <a:r>
                        <a:rPr lang="en-US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+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8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1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343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Kaempferol-3-O-arabinoside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.53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1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19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18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87 [posi]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93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Mass bank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.I. 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.74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2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29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28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346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2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latyphyllono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.79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1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15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14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97 [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osi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]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5, 366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307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CD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Kaempferol-3-O-rhamnoside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.86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3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3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32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85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92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TD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4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.I. 8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.93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62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629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628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71 &gt; 21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58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94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5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cerosid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 VIII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9.26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9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95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94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61 &gt; 299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95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TD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6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Quercetin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9.88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0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0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02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79, 15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66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95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TD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entrolobol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 derivatives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0.02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4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49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48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03 &gt; 461 &gt; 299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13, 28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92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CD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8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.I. 9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0.10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99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60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6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92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9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uteoli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0.10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85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8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86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6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66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92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TD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6-Hydroxy-1,7-bis(4-hydroxyphenyl)-4-hepten-3-one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0.21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1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1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12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67, 255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96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CD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Hirsuteno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0.49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2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51[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M+Na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]</a:t>
                      </a:r>
                      <a:r>
                        <a:rPr lang="en-US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+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28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7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93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CD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2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.I. 1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0.76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09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1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1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1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95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sorhamneti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0.81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15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1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16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53, 36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96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TD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4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Kaempfero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0.86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85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8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86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41, 213 [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osi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]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18, 265, 366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94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TD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5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.I. 1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0.90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4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92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6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lpineti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0.90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69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7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7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67 [posi]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91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Hespereti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0.93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0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0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02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86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2, 28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94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TD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8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aringeni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0.93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7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7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72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94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TD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9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.I. 12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0.99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2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29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28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11 [posi]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94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.I. 1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1.19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25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2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26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0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1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91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1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entrolobol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1.59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99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0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9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96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2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2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'-Deoxykanokoside C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1.76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62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62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622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36, 279, 30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93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CD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3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inosylvin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1.81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1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1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12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35 [posi]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13, 298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93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TD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4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4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.I. 14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1.85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95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9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96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93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5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5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.I. 15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1.85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4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92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6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6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.I. 16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2.08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69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7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7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16, 227, 30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93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7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inocembrin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2.78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55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57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56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13, 211, 151, 145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13, 289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25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9.00E-04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TD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8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8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,7-Bis-(4-hydroxyphenyl)-4,6-heptadien-3-one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2.87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93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95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94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51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15, 352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80 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E+00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Ref</a:t>
                      </a:r>
                    </a:p>
                  </a:txBody>
                  <a:tcPr marL="6117" marR="6117" marT="61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968034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31329" y="7884145"/>
            <a:ext cx="9132478" cy="43088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just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HPLC profiling chromatogram of 40% MeOH extract and (B) ABTS radical scavenging activities of odd-numbered preparative HPLC fractions. 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olox equivalent antioxidant capacity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11745"/>
            <a:ext cx="9563807" cy="777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55885963"/>
      </p:ext>
    </p:extLst>
  </p:cSld>
  <p:clrMapOvr>
    <a:masterClrMapping/>
  </p:clrMapOvr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g"/></Relationships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blipFill dpi="0" rotWithShape="1"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a:blipFill>
        <a:ln>
          <a:solidFill>
            <a:schemeClr val="tx1"/>
          </a:solidFill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문서" ma:contentTypeID="0x010100E28D525440B82C4C8C8E559D4BDE8287" ma:contentTypeVersion="0" ma:contentTypeDescription="새 문서를 만듭니다." ma:contentTypeScope="" ma:versionID="919510133f2ae86e1debdd944922310a">
  <xsd:schema xmlns:xsd="http://www.w3.org/2001/XMLSchema" xmlns:xs="http://www.w3.org/2001/XMLSchema" xmlns:p="http://schemas.microsoft.com/office/2006/metadata/properties" targetNamespace="http://schemas.microsoft.com/office/2006/metadata/properties" ma:root="true" ma:fieldsID="dd8f6c9257034a6ffde9c3b3e5e5b894">
    <xsd:element name="properties">
      <xsd:complexType>
        <xsd:sequence>
          <xsd:element name="documentManagement">
            <xsd:complexType>
              <xsd:all/>
            </xsd:complexType>
          </xsd:element>
        </xsd:sequence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콘텐츠 형식"/>
        <xsd:element ref="dc:title" minOccurs="0" maxOccurs="1" ma:index="4" ma:displayName="제목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30B4E994-6BC7-43B5-A465-CA4F0A17AFDA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D0571FF3-9302-46A7-907C-A2750FF0B76B}">
  <ds:schemaRefs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http://purl.org/dc/terms/"/>
    <ds:schemaRef ds:uri="http://schemas.openxmlformats.org/package/2006/metadata/core-properties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63A7913D-4047-4125-BE52-DACAE5599D56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3707592</TotalTime>
  <Words>998</Words>
  <Application>Microsoft Office PowerPoint</Application>
  <PresentationFormat>사용자 지정</PresentationFormat>
  <Paragraphs>550</Paragraphs>
  <Slides>3</Slides>
  <Notes>3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8" baseType="lpstr">
      <vt:lpstr>맑은 고딕</vt:lpstr>
      <vt:lpstr>Arial</vt:lpstr>
      <vt:lpstr>나눔바른고딕</vt:lpstr>
      <vt:lpstr>Times New Roman</vt:lpstr>
      <vt:lpstr>Office 테마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NSM</dc:creator>
  <cp:lastModifiedBy>SM</cp:lastModifiedBy>
  <cp:revision>2598</cp:revision>
  <cp:lastPrinted>2016-10-11T08:57:44Z</cp:lastPrinted>
  <dcterms:created xsi:type="dcterms:W3CDTF">2013-11-20T05:15:01Z</dcterms:created>
  <dcterms:modified xsi:type="dcterms:W3CDTF">2019-08-23T08:51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28D525440B82C4C8C8E559D4BDE8287</vt:lpwstr>
  </property>
</Properties>
</file>